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18" r:id="rId2"/>
  </p:sldIdLst>
  <p:sldSz cx="6858000" cy="9144000" type="letter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70" userDrawn="1">
          <p15:clr>
            <a:srgbClr val="A4A3A4"/>
          </p15:clr>
        </p15:guide>
        <p15:guide id="2" pos="250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5493"/>
    <a:srgbClr val="009193"/>
    <a:srgbClr val="0432FF"/>
    <a:srgbClr val="0325C7"/>
    <a:srgbClr val="003DA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824" autoAdjust="0"/>
    <p:restoredTop sz="95288" autoAdjust="0"/>
  </p:normalViewPr>
  <p:slideViewPr>
    <p:cSldViewPr snapToGrid="0" snapToObjects="1">
      <p:cViewPr varScale="1">
        <p:scale>
          <a:sx n="93" d="100"/>
          <a:sy n="93" d="100"/>
        </p:scale>
        <p:origin x="2322" y="78"/>
      </p:cViewPr>
      <p:guideLst>
        <p:guide orient="horz" pos="5670"/>
        <p:guide pos="250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866B31A-991B-9D41-B111-F5C313A711C3}" type="datetimeFigureOut">
              <a:rPr kumimoji="1" lang="ko-KR" altLang="en-US" smtClean="0"/>
              <a:t>2021-07-27</a:t>
            </a:fld>
            <a:endParaRPr kumimoji="1"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7AC6652-A023-D145-86FB-469CB08E6AEB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13819826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en-US" altLang="ja-JP"/>
              <a:t>Click to edit Master subtitle style</a:t>
            </a:r>
            <a:endParaRPr kumimoji="1" lang="ja-JP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93CE2-18D6-2D4B-B30B-21351ED06076}" type="datetimeFigureOut">
              <a:rPr kumimoji="1" lang="ja-JP" altLang="en-US" smtClean="0"/>
              <a:t>2021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69C29-0EA6-4C44-99F0-9E56CFCDE2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72553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93CE2-18D6-2D4B-B30B-21351ED06076}" type="datetimeFigureOut">
              <a:rPr kumimoji="1" lang="ja-JP" altLang="en-US" smtClean="0"/>
              <a:t>2021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69C29-0EA6-4C44-99F0-9E56CFCDE2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62350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93CE2-18D6-2D4B-B30B-21351ED06076}" type="datetimeFigureOut">
              <a:rPr kumimoji="1" lang="ja-JP" altLang="en-US" smtClean="0"/>
              <a:t>2021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69C29-0EA6-4C44-99F0-9E56CFCDE2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43914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93CE2-18D6-2D4B-B30B-21351ED06076}" type="datetimeFigureOut">
              <a:rPr kumimoji="1" lang="ja-JP" altLang="en-US" smtClean="0"/>
              <a:t>2021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69C29-0EA6-4C44-99F0-9E56CFCDE2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99956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en-US" altLang="ja-JP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93CE2-18D6-2D4B-B30B-21351ED06076}" type="datetimeFigureOut">
              <a:rPr kumimoji="1" lang="ja-JP" altLang="en-US" smtClean="0"/>
              <a:t>2021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69C29-0EA6-4C44-99F0-9E56CFCDE2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31040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93CE2-18D6-2D4B-B30B-21351ED06076}" type="datetimeFigureOut">
              <a:rPr kumimoji="1" lang="ja-JP" altLang="en-US" smtClean="0"/>
              <a:t>2021/7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69C29-0EA6-4C44-99F0-9E56CFCDE2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05608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en-US" altLang="ja-JP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en-US" altLang="ja-JP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93CE2-18D6-2D4B-B30B-21351ED06076}" type="datetimeFigureOut">
              <a:rPr kumimoji="1" lang="ja-JP" altLang="en-US" smtClean="0"/>
              <a:t>2021/7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69C29-0EA6-4C44-99F0-9E56CFCDE2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7361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93CE2-18D6-2D4B-B30B-21351ED06076}" type="datetimeFigureOut">
              <a:rPr kumimoji="1" lang="ja-JP" altLang="en-US" smtClean="0"/>
              <a:t>2021/7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69C29-0EA6-4C44-99F0-9E56CFCDE2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24893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93CE2-18D6-2D4B-B30B-21351ED06076}" type="datetimeFigureOut">
              <a:rPr kumimoji="1" lang="ja-JP" altLang="en-US" smtClean="0"/>
              <a:t>2021/7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69C29-0EA6-4C44-99F0-9E56CFCDE2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51308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en-US" altLang="ja-JP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93CE2-18D6-2D4B-B30B-21351ED06076}" type="datetimeFigureOut">
              <a:rPr kumimoji="1" lang="ja-JP" altLang="en-US" smtClean="0"/>
              <a:t>2021/7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69C29-0EA6-4C44-99F0-9E56CFCDE2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54064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en-US" altLang="ja-JP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93CE2-18D6-2D4B-B30B-21351ED06076}" type="datetimeFigureOut">
              <a:rPr kumimoji="1" lang="ja-JP" altLang="en-US" smtClean="0"/>
              <a:t>2021/7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D69C29-0EA6-4C44-99F0-9E56CFCDE2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44011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F93CE2-18D6-2D4B-B30B-21351ED06076}" type="datetimeFigureOut">
              <a:rPr kumimoji="1" lang="ja-JP" altLang="en-US" smtClean="0"/>
              <a:t>2021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D69C29-0EA6-4C44-99F0-9E56CFCDE2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4102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56">
            <a:extLst>
              <a:ext uri="{FF2B5EF4-FFF2-40B4-BE49-F238E27FC236}">
                <a16:creationId xmlns:a16="http://schemas.microsoft.com/office/drawing/2014/main" id="{BFE7E4FD-97DE-4A11-BAEB-41C0938CF21C}"/>
              </a:ext>
            </a:extLst>
          </p:cNvPr>
          <p:cNvSpPr txBox="1"/>
          <p:nvPr/>
        </p:nvSpPr>
        <p:spPr>
          <a:xfrm>
            <a:off x="4463331" y="384484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</a:t>
            </a:r>
            <a:r>
              <a: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6">
            <a:extLst>
              <a:ext uri="{FF2B5EF4-FFF2-40B4-BE49-F238E27FC236}">
                <a16:creationId xmlns:a16="http://schemas.microsoft.com/office/drawing/2014/main" id="{B4CCCF26-35E9-436A-9C4C-27537E1864B0}"/>
              </a:ext>
            </a:extLst>
          </p:cNvPr>
          <p:cNvSpPr txBox="1"/>
          <p:nvPr/>
        </p:nvSpPr>
        <p:spPr>
          <a:xfrm>
            <a:off x="463684" y="110640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6">
            <a:extLst>
              <a:ext uri="{FF2B5EF4-FFF2-40B4-BE49-F238E27FC236}">
                <a16:creationId xmlns:a16="http://schemas.microsoft.com/office/drawing/2014/main" id="{A0BE6524-C0E1-4339-A567-A01F5D41C11D}"/>
              </a:ext>
            </a:extLst>
          </p:cNvPr>
          <p:cNvSpPr txBox="1"/>
          <p:nvPr/>
        </p:nvSpPr>
        <p:spPr>
          <a:xfrm>
            <a:off x="4533605" y="110640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6">
            <a:extLst>
              <a:ext uri="{FF2B5EF4-FFF2-40B4-BE49-F238E27FC236}">
                <a16:creationId xmlns:a16="http://schemas.microsoft.com/office/drawing/2014/main" id="{0AE0C38D-CBC2-433D-AFAB-213796F0D10F}"/>
              </a:ext>
            </a:extLst>
          </p:cNvPr>
          <p:cNvSpPr txBox="1"/>
          <p:nvPr/>
        </p:nvSpPr>
        <p:spPr>
          <a:xfrm>
            <a:off x="2498644" y="110640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그림 6">
            <a:extLst>
              <a:ext uri="{FF2B5EF4-FFF2-40B4-BE49-F238E27FC236}">
                <a16:creationId xmlns:a16="http://schemas.microsoft.com/office/drawing/2014/main" id="{00D60F34-333E-4806-AB55-410132FC8BD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90860" y="1680545"/>
            <a:ext cx="1933807" cy="1657549"/>
          </a:xfrm>
          <a:prstGeom prst="rect">
            <a:avLst/>
          </a:prstGeom>
        </p:spPr>
      </p:pic>
      <p:pic>
        <p:nvPicPr>
          <p:cNvPr id="9" name="그림 8">
            <a:extLst>
              <a:ext uri="{FF2B5EF4-FFF2-40B4-BE49-F238E27FC236}">
                <a16:creationId xmlns:a16="http://schemas.microsoft.com/office/drawing/2014/main" id="{CBB9360E-64EF-4B82-969F-CC784033838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01605" y="1680545"/>
            <a:ext cx="1932000" cy="1656000"/>
          </a:xfrm>
          <a:prstGeom prst="rect">
            <a:avLst/>
          </a:prstGeom>
        </p:spPr>
      </p:pic>
      <p:pic>
        <p:nvPicPr>
          <p:cNvPr id="11" name="그림 10">
            <a:extLst>
              <a:ext uri="{FF2B5EF4-FFF2-40B4-BE49-F238E27FC236}">
                <a16:creationId xmlns:a16="http://schemas.microsoft.com/office/drawing/2014/main" id="{AF0A3E5D-BF1F-46A4-988E-08E6B9EE68B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66644" y="1680545"/>
            <a:ext cx="1932000" cy="165600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312B180A-8D4D-450C-80E4-D7C4B83EB67F}"/>
              </a:ext>
            </a:extLst>
          </p:cNvPr>
          <p:cNvSpPr txBox="1"/>
          <p:nvPr/>
        </p:nvSpPr>
        <p:spPr>
          <a:xfrm>
            <a:off x="1070934" y="1418394"/>
            <a:ext cx="1228221" cy="5355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90000"/>
              </a:lnSpc>
            </a:pP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Entire cohort</a:t>
            </a:r>
          </a:p>
          <a:p>
            <a:pPr algn="ctr">
              <a:lnSpc>
                <a:spcPct val="90000"/>
              </a:lnSpc>
            </a:pP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Median 13.0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mo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>
              <a:lnSpc>
                <a:spcPct val="90000"/>
              </a:lnSpc>
            </a:pP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(95% CI 12.3-14.2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mo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90000"/>
              </a:lnSpc>
            </a:pP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8178CA2-75AE-484B-9133-C1F778C6DC7D}"/>
              </a:ext>
            </a:extLst>
          </p:cNvPr>
          <p:cNvSpPr txBox="1"/>
          <p:nvPr/>
        </p:nvSpPr>
        <p:spPr>
          <a:xfrm>
            <a:off x="3105895" y="1414182"/>
            <a:ext cx="1228221" cy="5355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90000"/>
              </a:lnSpc>
            </a:pP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ko-KR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 line</a:t>
            </a:r>
          </a:p>
          <a:p>
            <a:pPr algn="ctr">
              <a:lnSpc>
                <a:spcPct val="90000"/>
              </a:lnSpc>
            </a:pP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Median 13.7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mo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>
              <a:lnSpc>
                <a:spcPct val="90000"/>
              </a:lnSpc>
            </a:pP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(95% CI 13.0-14.9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mo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90000"/>
              </a:lnSpc>
            </a:pP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56C6AD3-80E4-4BE4-8777-682AA543DEBC}"/>
              </a:ext>
            </a:extLst>
          </p:cNvPr>
          <p:cNvSpPr txBox="1"/>
          <p:nvPr/>
        </p:nvSpPr>
        <p:spPr>
          <a:xfrm>
            <a:off x="5224907" y="1368329"/>
            <a:ext cx="1170513" cy="5355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90000"/>
              </a:lnSpc>
            </a:pP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  <a:r>
              <a:rPr lang="en-US" altLang="ko-KR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rd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 line</a:t>
            </a:r>
          </a:p>
          <a:p>
            <a:pPr algn="ctr">
              <a:lnSpc>
                <a:spcPct val="90000"/>
              </a:lnSpc>
            </a:pP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Median 6.5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mo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>
              <a:lnSpc>
                <a:spcPct val="90000"/>
              </a:lnSpc>
            </a:pP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(95% CI 3.5-10.5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mo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90000"/>
              </a:lnSpc>
            </a:pP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828352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914</TotalTime>
  <Words>43</Words>
  <Application>Microsoft Office PowerPoint</Application>
  <PresentationFormat>Letter 용지(8.5x11in)</PresentationFormat>
  <Paragraphs>13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Calibri</vt:lpstr>
      <vt:lpstr>Office Theme</vt:lpstr>
      <vt:lpstr>PowerPoint 프레젠테이션</vt:lpstr>
    </vt:vector>
  </TitlesOfParts>
  <Company>KAIS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-Hyung Park</dc:creator>
  <cp:lastModifiedBy>Kim Hyungdon</cp:lastModifiedBy>
  <cp:revision>828</cp:revision>
  <cp:lastPrinted>2018-12-18T07:11:08Z</cp:lastPrinted>
  <dcterms:created xsi:type="dcterms:W3CDTF">2017-07-04T15:52:14Z</dcterms:created>
  <dcterms:modified xsi:type="dcterms:W3CDTF">2021-07-27T09:23:24Z</dcterms:modified>
</cp:coreProperties>
</file>